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57" r:id="rId4"/>
    <p:sldId id="258" r:id="rId5"/>
    <p:sldId id="261" r:id="rId6"/>
    <p:sldId id="262" r:id="rId7"/>
    <p:sldId id="263" r:id="rId8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3204" y="9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6A8A815-4E1A-4943-A790-7BACF3FC59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76400" y="2057400"/>
            <a:ext cx="2292473" cy="5372983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2EA28DB6-2E98-4098-B4B2-AB979E68AB44}"/>
              </a:ext>
            </a:extLst>
          </p:cNvPr>
          <p:cNvSpPr txBox="1"/>
          <p:nvPr/>
        </p:nvSpPr>
        <p:spPr>
          <a:xfrm>
            <a:off x="1836356" y="1803484"/>
            <a:ext cx="22924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M         1              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7917160-AD7C-4207-9C3F-52A318AE94BA}"/>
              </a:ext>
            </a:extLst>
          </p:cNvPr>
          <p:cNvSpPr txBox="1"/>
          <p:nvPr/>
        </p:nvSpPr>
        <p:spPr>
          <a:xfrm>
            <a:off x="72812" y="480677"/>
            <a:ext cx="61865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a: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CR Amplification of Internal Transcribed Spacer (ITS)</a:t>
            </a:r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Rectangle 29">
            <a:extLst>
              <a:ext uri="{FF2B5EF4-FFF2-40B4-BE49-F238E27FC236}">
                <a16:creationId xmlns:a16="http://schemas.microsoft.com/office/drawing/2014/main" id="{FF0E92D8-A81D-4755-AEB9-3A89A3CF44FD}"/>
              </a:ext>
            </a:extLst>
          </p:cNvPr>
          <p:cNvSpPr/>
          <p:nvPr/>
        </p:nvSpPr>
        <p:spPr>
          <a:xfrm>
            <a:off x="3173160" y="8273284"/>
            <a:ext cx="52290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EF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2A89A50-D75F-41CB-8E05-62D66B939227}"/>
              </a:ext>
            </a:extLst>
          </p:cNvPr>
          <p:cNvSpPr txBox="1"/>
          <p:nvPr/>
        </p:nvSpPr>
        <p:spPr>
          <a:xfrm>
            <a:off x="2362200" y="1806607"/>
            <a:ext cx="2895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M              1               2 </a:t>
            </a:r>
          </a:p>
        </p:txBody>
      </p:sp>
      <p:graphicFrame>
        <p:nvGraphicFramePr>
          <p:cNvPr id="32" name="Object 31">
            <a:extLst>
              <a:ext uri="{FF2B5EF4-FFF2-40B4-BE49-F238E27FC236}">
                <a16:creationId xmlns:a16="http://schemas.microsoft.com/office/drawing/2014/main" id="{3B8C540D-BDE8-4CD2-8B9B-F7F0EC43CC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0729235"/>
              </p:ext>
            </p:extLst>
          </p:nvPr>
        </p:nvGraphicFramePr>
        <p:xfrm>
          <a:off x="2209800" y="2057400"/>
          <a:ext cx="2514600" cy="59901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2" imgW="6133320" imgH="14628240" progId="Photoshop.Image.7">
                  <p:embed/>
                </p:oleObj>
              </mc:Choice>
              <mc:Fallback>
                <p:oleObj name="Image" r:id="rId2" imgW="6133320" imgH="14628240" progId="Photoshop.Image.7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87C0C4AA-D81B-45A8-9D73-5A0C845A739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209800" y="2057400"/>
                        <a:ext cx="2514600" cy="59901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TextBox 36">
            <a:extLst>
              <a:ext uri="{FF2B5EF4-FFF2-40B4-BE49-F238E27FC236}">
                <a16:creationId xmlns:a16="http://schemas.microsoft.com/office/drawing/2014/main" id="{1A8477A3-35EF-4133-8A56-2D23B798A8E5}"/>
              </a:ext>
            </a:extLst>
          </p:cNvPr>
          <p:cNvSpPr txBox="1"/>
          <p:nvPr/>
        </p:nvSpPr>
        <p:spPr>
          <a:xfrm>
            <a:off x="208503" y="670392"/>
            <a:ext cx="644099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b: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CR Amplification of Transcription Elongation Factor (TEF)</a:t>
            </a:r>
          </a:p>
          <a:p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980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Rectangle 23">
            <a:extLst>
              <a:ext uri="{FF2B5EF4-FFF2-40B4-BE49-F238E27FC236}">
                <a16:creationId xmlns:a16="http://schemas.microsoft.com/office/drawing/2014/main" id="{3752C7E3-5E2F-4AF1-92F4-09A085029862}"/>
              </a:ext>
            </a:extLst>
          </p:cNvPr>
          <p:cNvSpPr/>
          <p:nvPr/>
        </p:nvSpPr>
        <p:spPr>
          <a:xfrm>
            <a:off x="2648973" y="630441"/>
            <a:ext cx="2122205" cy="364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Capsicum annuum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L.</a:t>
            </a:r>
            <a:endParaRPr lang="en-US" sz="1200" b="1" dirty="0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5848E202-30D5-41D5-8B32-524D7AFE89A4}"/>
              </a:ext>
            </a:extLst>
          </p:cNvPr>
          <p:cNvSpPr/>
          <p:nvPr/>
        </p:nvSpPr>
        <p:spPr>
          <a:xfrm>
            <a:off x="4132066" y="3614978"/>
            <a:ext cx="1228192" cy="32414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acroconidia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51CBB7E0-A067-430C-B771-815063C325A1}"/>
              </a:ext>
            </a:extLst>
          </p:cNvPr>
          <p:cNvSpPr txBox="1"/>
          <p:nvPr/>
        </p:nvSpPr>
        <p:spPr>
          <a:xfrm>
            <a:off x="471485" y="194750"/>
            <a:ext cx="42915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a: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hili macro and microspore </a:t>
            </a:r>
          </a:p>
          <a:p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45C7C78C-748F-4ACC-9BA8-9C136DADA99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0958" y="1020723"/>
            <a:ext cx="5358234" cy="401867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6693ED06-CE71-4EE5-A7E1-9EEE6F31960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0958" y="5236413"/>
            <a:ext cx="5358232" cy="401867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278F56F4-E07B-4257-B624-83678213D36B}"/>
              </a:ext>
            </a:extLst>
          </p:cNvPr>
          <p:cNvSpPr/>
          <p:nvPr/>
        </p:nvSpPr>
        <p:spPr>
          <a:xfrm rot="16200000">
            <a:off x="-347286" y="2551777"/>
            <a:ext cx="203837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icroconidia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9BE2C10C-5F72-4F8B-B44A-2D22A9F4D449}"/>
              </a:ext>
            </a:extLst>
          </p:cNvPr>
          <p:cNvSpPr/>
          <p:nvPr/>
        </p:nvSpPr>
        <p:spPr>
          <a:xfrm rot="16200000">
            <a:off x="98475" y="7307963"/>
            <a:ext cx="117692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acroconidia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angle 18">
            <a:extLst>
              <a:ext uri="{FF2B5EF4-FFF2-40B4-BE49-F238E27FC236}">
                <a16:creationId xmlns:a16="http://schemas.microsoft.com/office/drawing/2014/main" id="{B62E0027-99CF-4432-BD58-F64093AC6AFB}"/>
              </a:ext>
            </a:extLst>
          </p:cNvPr>
          <p:cNvSpPr/>
          <p:nvPr/>
        </p:nvSpPr>
        <p:spPr>
          <a:xfrm>
            <a:off x="2438400" y="395243"/>
            <a:ext cx="3243191" cy="59740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olanum melongena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.</a:t>
            </a:r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7D7ABA7-FCB6-4147-B7A4-48A8CAA782E2}"/>
              </a:ext>
            </a:extLst>
          </p:cNvPr>
          <p:cNvSpPr txBox="1"/>
          <p:nvPr/>
        </p:nvSpPr>
        <p:spPr>
          <a:xfrm>
            <a:off x="533400" y="99262"/>
            <a:ext cx="4350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b: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rinjal macro and microspore 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C16D2D77-B579-4DE6-830C-EC5B07BEAA8F}"/>
              </a:ext>
            </a:extLst>
          </p:cNvPr>
          <p:cNvSpPr/>
          <p:nvPr/>
        </p:nvSpPr>
        <p:spPr>
          <a:xfrm rot="16200000">
            <a:off x="-347286" y="2551777"/>
            <a:ext cx="203837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icroconidia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1CA17AA8-6B6F-404B-9810-330E1FA3CD92}"/>
              </a:ext>
            </a:extLst>
          </p:cNvPr>
          <p:cNvSpPr/>
          <p:nvPr/>
        </p:nvSpPr>
        <p:spPr>
          <a:xfrm rot="16200000">
            <a:off x="98475" y="7307963"/>
            <a:ext cx="117692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acroconidia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E9450DB4-6C81-44CE-90DD-D3131F6743A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4300" y="4988257"/>
            <a:ext cx="5638800" cy="42291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131D3B0A-899F-49C3-9CFB-04B043E9D64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4300" y="697743"/>
            <a:ext cx="5638800" cy="42291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F622E60-3E0A-457E-A78B-A19236959E4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180" y="762000"/>
            <a:ext cx="5358232" cy="401867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63F5585-0080-4FC9-9E62-8F14DF151D6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335" y="5361656"/>
            <a:ext cx="5358232" cy="401867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DCBB635-AB72-42B3-8310-500A6CFC0CF5}"/>
              </a:ext>
            </a:extLst>
          </p:cNvPr>
          <p:cNvSpPr txBox="1"/>
          <p:nvPr/>
        </p:nvSpPr>
        <p:spPr>
          <a:xfrm>
            <a:off x="533400" y="99262"/>
            <a:ext cx="32800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c: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hlamydospore</a:t>
            </a:r>
          </a:p>
          <a:p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CF770F5-FE0D-4795-93E0-93FEF2FB2693}"/>
              </a:ext>
            </a:extLst>
          </p:cNvPr>
          <p:cNvSpPr/>
          <p:nvPr/>
        </p:nvSpPr>
        <p:spPr>
          <a:xfrm>
            <a:off x="2286000" y="4981747"/>
            <a:ext cx="3243191" cy="59740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olanum melongena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.</a:t>
            </a:r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ED11C08-BEC9-4B9E-8537-A06C9D70067E}"/>
              </a:ext>
            </a:extLst>
          </p:cNvPr>
          <p:cNvSpPr/>
          <p:nvPr/>
        </p:nvSpPr>
        <p:spPr>
          <a:xfrm>
            <a:off x="2667000" y="480500"/>
            <a:ext cx="2122205" cy="364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Capsicum annuum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L.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3689849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EE0852A0-A7E9-BF51-ADAD-DC774AFB64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3400" y="2275"/>
            <a:ext cx="6179897" cy="99488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able S1- </a:t>
            </a:r>
            <a:r>
              <a:rPr lang="en-IN" sz="1400" b="1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BankIt2616938</a:t>
            </a:r>
            <a:endParaRPr kumimoji="0" lang="en-US" altLang="en-US" sz="1400" b="1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LOCUS       B_CAL2                   672 bp    DNA     linear   PLN 27-AUG-2022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DEFINITION  Fusarium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hlamydosporum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.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CCESSION   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VERSION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KEYWORDS    .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SOURCE      Fusarium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hlamydosporum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ORGANISM  Fusarium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hlamydosporum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Eukaryot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; Fungi;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Dikary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; Ascomycota;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Pezizomycotin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;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Sordariomycetes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;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Hypocreomycetidae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; Hypocreales;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Nectriaceae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;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Fusarium; Fusarium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hlamydosporum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species complex.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REFERENCE   1  (bases 1 to 672)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AUTHORS   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Parihar,T.J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.,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Hakak,A.S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.,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Khursheed,S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. and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Masoodi,K.Z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.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TITLE     DNA Barcoding of Wilt causing pathogen in Solanaceous crops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JOURNAL   Unpublished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REFERENCE   2  (bases 1 to 672)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AUTHORS   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Parihar,T.J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.,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Hakak,A.S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.,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Khursheed,S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. and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Masoodi,K.Z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.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TITLE     Direct Submission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JOURNAL   Submitted (27-AUG-2022) Division of Plant Biotechnology,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SKUAST-Kashmir, Shalimar, Srinagar, J&amp;K 190025, India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OMMENT     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Banki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Comment: LocalID:B_CAL2.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Banki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Comment: BankIt2616938.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##Assembly-Data-START##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Sequencing Technology :: Sanger dideoxy sequencing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##Assembly-Data-END##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FEATURES             Location/Qualifiers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source          1..672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/organism="Fusarium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hlamydosporum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"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/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mol_type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="genomic DNA"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/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isolation_source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="Brinjal"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/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db_xref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="taxon:86545"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/country="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India:J&amp;K,Anantnag,Kokarna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"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/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ollection_date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="22-Oct-2020"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gene            1..672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/gene="CAL2"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CDS             1..672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/gene="CAL2"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/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odon_star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=1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/product="CAL2"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/translation="-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VAVANLAVQDKDGDGERCCPFSRRAFTGPSRYPNKPK*SLKWIYTIAFAFFWGQRGR*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NMG*TLTTGQITTKELGTVMRSLGQNPSESELQDMINEVDADNNGTIDFPGALFLKMI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AE*RH*HGRKEFLTMMARKMKDTDSEEEIREAFKVFDRDNNGFISAAELRHVMTSIGE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KLTGEEVDEMIREADQDGDGRIDCELLTD*IIETPHVYCC*PFV*TTSS"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BASE COUNT      177 a    167 c    178 g    150 t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ORIGIN     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ttgtagcc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tgctaatc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gctgtaca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acaaggat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tgatggtg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cgatgctgc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6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ctttttcg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acgagcct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actggccc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gccgatat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aaataaac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aaataaagc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12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ttaaatgg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atacacga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gcattcgc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tcttttgg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tcaacgtg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cgataaaac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18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tgggctaa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actcacta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ggtcagat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ccaccaag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gcttggaa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gtcatgcgc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24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ctctcggt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gaacccct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gagtccga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ttcaggac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gatcaacg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gttgacgcc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30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acaacaac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caccatcg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ttccctgg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cgttattt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taagatga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gcagaatga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36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gacactga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tgggagaa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gaattcct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ccatgatg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gcgcaaga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aaggacacc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42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actccgag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ggagatcc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gaggcttt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aggtgttc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ccgtgaca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aacggcttt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48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tctccgct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cgaactcc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catgtcat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cctccatc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cgagaagc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actggggag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54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aggtcgat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gatgatcc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gaggctga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aggacggt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tggccgga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gactgtgag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60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tgcttacg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ctgaataa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gaaacgcc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atgtatac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ttgctaac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tttgtgtag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66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caacgagt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cg</a:t>
            </a:r>
            <a:endParaRPr kumimoji="0" lang="en-US" altLang="en-US" sz="105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2263646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76AE06E-0BCE-7A11-075F-47230D7A1483}"/>
              </a:ext>
            </a:extLst>
          </p:cNvPr>
          <p:cNvSpPr txBox="1"/>
          <p:nvPr/>
        </p:nvSpPr>
        <p:spPr>
          <a:xfrm>
            <a:off x="533400" y="152400"/>
            <a:ext cx="6019800" cy="99488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able S2: </a:t>
            </a:r>
            <a:r>
              <a:rPr lang="en-IN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BankIt2616965</a:t>
            </a:r>
            <a:endParaRPr kumimoji="0" lang="en-US" altLang="en-US" sz="1200" b="1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cs typeface="Arial" panose="020B0604020202020204" pitchFamily="34" charset="0"/>
            </a:endParaRPr>
          </a:p>
          <a:p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LOCUS       C_CAL2                   698 bp    DNA     linear   PLN 27-AUG-2022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DEFINITION  Fusarium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hlamydosporum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.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CCESSION   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VERSION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KEYWORDS    .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SOURCE      Fusarium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hlamydosporum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ORGANISM  Fusarium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hlamydosporum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Eukaryot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; Fungi;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Dikary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; Ascomycota;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Pezizomycotin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;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Sordariomycetes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;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Hypocreomycetidae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; Hypocreales;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Nectriaceae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;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Fusarium; Fusarium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hlamydosporum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species complex.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REFERENCE   1  (bases 1 to 698)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AUTHORS   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Parihar,T.J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.,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Hakak,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.,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Khursheed,S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. and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Masoodi,K.Z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.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TITLE     DNA Barcoding of Wilt causing pathogen in Solanaceous crops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JOURNAL   Unpublished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REFERENCE   2  (bases 1 to 698)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AUTHORS   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Parihar,T.J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.,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Hakak,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.,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Khursheed,S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. and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Masoodi,K.Z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.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TITLE     Direct Submission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JOURNAL   Submitted (27-AUG-2022) Division of Plant Biotechnology,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SKUAST-Kashmir, Shalimar, Srinagar, J&amp;K 190025, India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OMMENT     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Banki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Comment: LocalID:C_CAL2.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Banki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Comment: BankIt2616965.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##Assembly-Data-START##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Sequencing Technology :: Sanger dideoxy sequencing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##Assembly-Data-END##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FEATURES             Location/Qualifiers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source          1..698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/organism="Fusarium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hlamydosporum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"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/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mol_type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="genomic DNA"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/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isolation_source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="Chili"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/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db_xref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="taxon:86545"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/country="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India:J&amp;K,Baraml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,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Sopore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"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/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ollection_date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="10-Oct-2020"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gene            1..698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/gene="CAL2"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CDS             1..698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/gene="CAL2"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/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odon_star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=1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/product="CAL2"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/translation="-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CKSTLLTWL*PLLISLYRTRMVMVSDAALFRDEPSLAPADIQINPNKALNGYTRSHSH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SFGVNVVDKTWAKHLLQARSLLRSSVPSCALSARTPPSLSFRT*SMRSTLTTTALSTS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LVRYFLDRLKNHDTNIEEKSSLP*WRAR*RTPTPRRRSARPSRFSTVITTASFPLLNS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DMS*PLLERSSPMTRSMR*SGRLIRTVMAGSTVSCLRTE**KRRMYTVANHLCRQRVR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             "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BASE COUNT      182 a    168 c    179 g    169 t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ORIGIN     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 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tttgtaag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gacactct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acttggtt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agccgttg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aatctcgc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tacaggaca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 6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ggatggtg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ggtgagcg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gctgccct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ttcgcgac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gccttcac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gccccagcc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12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atatccaa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aaacccaa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aaagcctt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atggatat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acgatcgc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tcgcattct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18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ttggggtc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cgtggtcg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aaaacatg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ctaaacat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gttacagg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agatcacta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24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taaggagc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ggtaccgt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tgcgctct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cggccaga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ccctccga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ctgagcttc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30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ggacatga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aatgaggt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acgctgac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caacggca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atcgactt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ctggtgcgt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36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atttctta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ccggctga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aatcatga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ctaatatt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agaaaaga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tccttacca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42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gatggcgc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aagatgaa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acaccgac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cgaggagg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atccgcga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ccttcaagg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48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tttcgacc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gataacaa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gcttcatt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cgctgctg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ctccgaca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tcatgacct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54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tattggag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aagctcac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atgacgag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cgatgaga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atccggga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ctgatcagg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60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cggtgatg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cggatcga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gtgagttgc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tacggact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ataataga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acgccgcatg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      661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tatactgttg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taaccattt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gtgtagacaa</a:t>
            </a:r>
            <a: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50" b="0" i="0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cs typeface="Arial" panose="020B0604020202020204" pitchFamily="34" charset="0"/>
              </a:rPr>
              <a:t>cgagttcg</a:t>
            </a:r>
            <a:br>
              <a:rPr kumimoji="0" lang="en-US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</a:br>
            <a:endParaRPr lang="en-IN" sz="1050" dirty="0"/>
          </a:p>
        </p:txBody>
      </p:sp>
    </p:spTree>
    <p:extLst>
      <p:ext uri="{BB962C8B-B14F-4D97-AF65-F5344CB8AC3E}">
        <p14:creationId xmlns:p14="http://schemas.microsoft.com/office/powerpoint/2010/main" val="24199882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9</TotalTime>
  <Words>1044</Words>
  <Application>Microsoft Office PowerPoint</Application>
  <PresentationFormat>A4 Paper (210x297 mm)</PresentationFormat>
  <Paragraphs>21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Office Theme</vt:lpstr>
      <vt:lpstr>Imag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est buy</dc:creator>
  <cp:lastModifiedBy>Khalid Masoodi</cp:lastModifiedBy>
  <cp:revision>20</cp:revision>
  <dcterms:created xsi:type="dcterms:W3CDTF">2006-08-16T00:00:00Z</dcterms:created>
  <dcterms:modified xsi:type="dcterms:W3CDTF">2022-08-30T12:10:18Z</dcterms:modified>
</cp:coreProperties>
</file>